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81" r:id="rId2"/>
  </p:sldIdLst>
  <p:sldSz cx="6627813" cy="8229600"/>
  <p:notesSz cx="6797675" cy="9926638"/>
  <p:defaultTextStyle>
    <a:defPPr>
      <a:defRPr lang="en-US"/>
    </a:defPPr>
    <a:lvl1pPr marL="0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1pPr>
    <a:lvl2pPr marL="465841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2pPr>
    <a:lvl3pPr marL="931682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3pPr>
    <a:lvl4pPr marL="1397523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4pPr>
    <a:lvl5pPr marL="1863364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5pPr>
    <a:lvl6pPr marL="2329205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6pPr>
    <a:lvl7pPr marL="2795046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7pPr>
    <a:lvl8pPr marL="3260888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8pPr>
    <a:lvl9pPr marL="3726729" algn="l" defTabSz="931682" rtl="0" eaLnBrk="1" latinLnBrk="0" hangingPunct="1">
      <a:defRPr sz="183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69" autoAdjust="0"/>
    <p:restoredTop sz="88977" autoAdjust="0"/>
  </p:normalViewPr>
  <p:slideViewPr>
    <p:cSldViewPr snapToGrid="0">
      <p:cViewPr varScale="1">
        <p:scale>
          <a:sx n="68" d="100"/>
          <a:sy n="68" d="100"/>
        </p:scale>
        <p:origin x="7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60" cy="498056"/>
          </a:xfrm>
          <a:prstGeom prst="rect">
            <a:avLst/>
          </a:prstGeom>
        </p:spPr>
        <p:txBody>
          <a:bodyPr vert="horz" lIns="91361" tIns="45681" rIns="91361" bIns="4568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60" cy="498056"/>
          </a:xfrm>
          <a:prstGeom prst="rect">
            <a:avLst/>
          </a:prstGeom>
        </p:spPr>
        <p:txBody>
          <a:bodyPr vert="horz" lIns="91361" tIns="45681" rIns="91361" bIns="45681" rtlCol="0"/>
          <a:lstStyle>
            <a:lvl1pPr algn="r">
              <a:defRPr sz="1200"/>
            </a:lvl1pPr>
          </a:lstStyle>
          <a:p>
            <a:fld id="{C5D40AFF-1C51-4ABB-BD6B-D0EE3408014B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49463" y="1241425"/>
            <a:ext cx="2698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61" tIns="45681" rIns="91361" bIns="45681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4"/>
          </a:xfrm>
          <a:prstGeom prst="rect">
            <a:avLst/>
          </a:prstGeom>
        </p:spPr>
        <p:txBody>
          <a:bodyPr vert="horz" lIns="91361" tIns="45681" rIns="91361" bIns="45681" rtlCol="0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60" cy="498055"/>
          </a:xfrm>
          <a:prstGeom prst="rect">
            <a:avLst/>
          </a:prstGeom>
        </p:spPr>
        <p:txBody>
          <a:bodyPr vert="horz" lIns="91361" tIns="45681" rIns="91361" bIns="4568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60" cy="498055"/>
          </a:xfrm>
          <a:prstGeom prst="rect">
            <a:avLst/>
          </a:prstGeom>
        </p:spPr>
        <p:txBody>
          <a:bodyPr vert="horz" lIns="91361" tIns="45681" rIns="91361" bIns="45681" rtlCol="0" anchor="b"/>
          <a:lstStyle>
            <a:lvl1pPr algn="r">
              <a:defRPr sz="1200"/>
            </a:lvl1pPr>
          </a:lstStyle>
          <a:p>
            <a:fld id="{63E91E67-22E1-4F8C-A6ED-04C89FD84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515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1pPr>
    <a:lvl2pPr marL="465841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2pPr>
    <a:lvl3pPr marL="931682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3pPr>
    <a:lvl4pPr marL="1397523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4pPr>
    <a:lvl5pPr marL="1863364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5pPr>
    <a:lvl6pPr marL="2329205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6pPr>
    <a:lvl7pPr marL="2795046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7pPr>
    <a:lvl8pPr marL="3260888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8pPr>
    <a:lvl9pPr marL="3726729" algn="l" defTabSz="931682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7086" y="1346836"/>
            <a:ext cx="5633641" cy="2865120"/>
          </a:xfrm>
        </p:spPr>
        <p:txBody>
          <a:bodyPr anchor="b"/>
          <a:lstStyle>
            <a:lvl1pPr algn="ctr">
              <a:defRPr sz="434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8477" y="4322446"/>
            <a:ext cx="4970860" cy="1986914"/>
          </a:xfrm>
        </p:spPr>
        <p:txBody>
          <a:bodyPr/>
          <a:lstStyle>
            <a:lvl1pPr marL="0" indent="0" algn="ctr">
              <a:buNone/>
              <a:defRPr sz="1740"/>
            </a:lvl1pPr>
            <a:lvl2pPr marL="331379" indent="0" algn="ctr">
              <a:buNone/>
              <a:defRPr sz="1450"/>
            </a:lvl2pPr>
            <a:lvl3pPr marL="662757" indent="0" algn="ctr">
              <a:buNone/>
              <a:defRPr sz="1305"/>
            </a:lvl3pPr>
            <a:lvl4pPr marL="994136" indent="0" algn="ctr">
              <a:buNone/>
              <a:defRPr sz="1160"/>
            </a:lvl4pPr>
            <a:lvl5pPr marL="1325514" indent="0" algn="ctr">
              <a:buNone/>
              <a:defRPr sz="1160"/>
            </a:lvl5pPr>
            <a:lvl6pPr marL="1656893" indent="0" algn="ctr">
              <a:buNone/>
              <a:defRPr sz="1160"/>
            </a:lvl6pPr>
            <a:lvl7pPr marL="1988271" indent="0" algn="ctr">
              <a:buNone/>
              <a:defRPr sz="1160"/>
            </a:lvl7pPr>
            <a:lvl8pPr marL="2319650" indent="0" algn="ctr">
              <a:buNone/>
              <a:defRPr sz="1160"/>
            </a:lvl8pPr>
            <a:lvl9pPr marL="2651028" indent="0" algn="ctr">
              <a:buNone/>
              <a:defRPr sz="116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36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76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43029" y="438150"/>
            <a:ext cx="1429122" cy="697420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5662" y="438150"/>
            <a:ext cx="4204519" cy="697420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658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52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2210" y="2051688"/>
            <a:ext cx="5716489" cy="3423284"/>
          </a:xfrm>
        </p:spPr>
        <p:txBody>
          <a:bodyPr anchor="b"/>
          <a:lstStyle>
            <a:lvl1pPr>
              <a:defRPr sz="434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2210" y="5507358"/>
            <a:ext cx="5716489" cy="1800224"/>
          </a:xfrm>
        </p:spPr>
        <p:txBody>
          <a:bodyPr/>
          <a:lstStyle>
            <a:lvl1pPr marL="0" indent="0">
              <a:buNone/>
              <a:defRPr sz="1740">
                <a:solidFill>
                  <a:schemeClr val="tx1"/>
                </a:solidFill>
              </a:defRPr>
            </a:lvl1pPr>
            <a:lvl2pPr marL="331379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2pPr>
            <a:lvl3pPr marL="662757" indent="0">
              <a:buNone/>
              <a:defRPr sz="1305">
                <a:solidFill>
                  <a:schemeClr val="tx1">
                    <a:tint val="75000"/>
                  </a:schemeClr>
                </a:solidFill>
              </a:defRPr>
            </a:lvl3pPr>
            <a:lvl4pPr marL="994136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4pPr>
            <a:lvl5pPr marL="1325514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5pPr>
            <a:lvl6pPr marL="1656893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6pPr>
            <a:lvl7pPr marL="1988271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7pPr>
            <a:lvl8pPr marL="2319650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8pPr>
            <a:lvl9pPr marL="2651028" indent="0">
              <a:buNone/>
              <a:defRPr sz="1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408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5662" y="2190750"/>
            <a:ext cx="2816821" cy="52216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55330" y="2190750"/>
            <a:ext cx="2816821" cy="52216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257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6525" y="438152"/>
            <a:ext cx="5716489" cy="1590676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6526" y="2017396"/>
            <a:ext cx="2803875" cy="988694"/>
          </a:xfrm>
        </p:spPr>
        <p:txBody>
          <a:bodyPr anchor="b"/>
          <a:lstStyle>
            <a:lvl1pPr marL="0" indent="0">
              <a:buNone/>
              <a:defRPr sz="1740" b="1"/>
            </a:lvl1pPr>
            <a:lvl2pPr marL="331379" indent="0">
              <a:buNone/>
              <a:defRPr sz="1450" b="1"/>
            </a:lvl2pPr>
            <a:lvl3pPr marL="662757" indent="0">
              <a:buNone/>
              <a:defRPr sz="1305" b="1"/>
            </a:lvl3pPr>
            <a:lvl4pPr marL="994136" indent="0">
              <a:buNone/>
              <a:defRPr sz="1160" b="1"/>
            </a:lvl4pPr>
            <a:lvl5pPr marL="1325514" indent="0">
              <a:buNone/>
              <a:defRPr sz="1160" b="1"/>
            </a:lvl5pPr>
            <a:lvl6pPr marL="1656893" indent="0">
              <a:buNone/>
              <a:defRPr sz="1160" b="1"/>
            </a:lvl6pPr>
            <a:lvl7pPr marL="1988271" indent="0">
              <a:buNone/>
              <a:defRPr sz="1160" b="1"/>
            </a:lvl7pPr>
            <a:lvl8pPr marL="2319650" indent="0">
              <a:buNone/>
              <a:defRPr sz="1160" b="1"/>
            </a:lvl8pPr>
            <a:lvl9pPr marL="2651028" indent="0">
              <a:buNone/>
              <a:defRPr sz="116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6526" y="3006090"/>
            <a:ext cx="2803875" cy="44215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55331" y="2017396"/>
            <a:ext cx="2817684" cy="988694"/>
          </a:xfrm>
        </p:spPr>
        <p:txBody>
          <a:bodyPr anchor="b"/>
          <a:lstStyle>
            <a:lvl1pPr marL="0" indent="0">
              <a:buNone/>
              <a:defRPr sz="1740" b="1"/>
            </a:lvl1pPr>
            <a:lvl2pPr marL="331379" indent="0">
              <a:buNone/>
              <a:defRPr sz="1450" b="1"/>
            </a:lvl2pPr>
            <a:lvl3pPr marL="662757" indent="0">
              <a:buNone/>
              <a:defRPr sz="1305" b="1"/>
            </a:lvl3pPr>
            <a:lvl4pPr marL="994136" indent="0">
              <a:buNone/>
              <a:defRPr sz="1160" b="1"/>
            </a:lvl4pPr>
            <a:lvl5pPr marL="1325514" indent="0">
              <a:buNone/>
              <a:defRPr sz="1160" b="1"/>
            </a:lvl5pPr>
            <a:lvl6pPr marL="1656893" indent="0">
              <a:buNone/>
              <a:defRPr sz="1160" b="1"/>
            </a:lvl6pPr>
            <a:lvl7pPr marL="1988271" indent="0">
              <a:buNone/>
              <a:defRPr sz="1160" b="1"/>
            </a:lvl7pPr>
            <a:lvl8pPr marL="2319650" indent="0">
              <a:buNone/>
              <a:defRPr sz="1160" b="1"/>
            </a:lvl8pPr>
            <a:lvl9pPr marL="2651028" indent="0">
              <a:buNone/>
              <a:defRPr sz="116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55331" y="3006090"/>
            <a:ext cx="2817684" cy="442150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457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969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63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6526" y="548640"/>
            <a:ext cx="2137642" cy="1920240"/>
          </a:xfrm>
        </p:spPr>
        <p:txBody>
          <a:bodyPr anchor="b"/>
          <a:lstStyle>
            <a:lvl1pPr>
              <a:defRPr sz="231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7684" y="1184912"/>
            <a:ext cx="3355330" cy="5848350"/>
          </a:xfrm>
        </p:spPr>
        <p:txBody>
          <a:bodyPr/>
          <a:lstStyle>
            <a:lvl1pPr>
              <a:defRPr sz="2319"/>
            </a:lvl1pPr>
            <a:lvl2pPr>
              <a:defRPr sz="2029"/>
            </a:lvl2pPr>
            <a:lvl3pPr>
              <a:defRPr sz="1740"/>
            </a:lvl3pPr>
            <a:lvl4pPr>
              <a:defRPr sz="1450"/>
            </a:lvl4pPr>
            <a:lvl5pPr>
              <a:defRPr sz="1450"/>
            </a:lvl5pPr>
            <a:lvl6pPr>
              <a:defRPr sz="1450"/>
            </a:lvl6pPr>
            <a:lvl7pPr>
              <a:defRPr sz="1450"/>
            </a:lvl7pPr>
            <a:lvl8pPr>
              <a:defRPr sz="1450"/>
            </a:lvl8pPr>
            <a:lvl9pPr>
              <a:defRPr sz="14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6526" y="2468880"/>
            <a:ext cx="2137642" cy="4573906"/>
          </a:xfrm>
        </p:spPr>
        <p:txBody>
          <a:bodyPr/>
          <a:lstStyle>
            <a:lvl1pPr marL="0" indent="0">
              <a:buNone/>
              <a:defRPr sz="1160"/>
            </a:lvl1pPr>
            <a:lvl2pPr marL="331379" indent="0">
              <a:buNone/>
              <a:defRPr sz="1015"/>
            </a:lvl2pPr>
            <a:lvl3pPr marL="662757" indent="0">
              <a:buNone/>
              <a:defRPr sz="870"/>
            </a:lvl3pPr>
            <a:lvl4pPr marL="994136" indent="0">
              <a:buNone/>
              <a:defRPr sz="725"/>
            </a:lvl4pPr>
            <a:lvl5pPr marL="1325514" indent="0">
              <a:buNone/>
              <a:defRPr sz="725"/>
            </a:lvl5pPr>
            <a:lvl6pPr marL="1656893" indent="0">
              <a:buNone/>
              <a:defRPr sz="725"/>
            </a:lvl6pPr>
            <a:lvl7pPr marL="1988271" indent="0">
              <a:buNone/>
              <a:defRPr sz="725"/>
            </a:lvl7pPr>
            <a:lvl8pPr marL="2319650" indent="0">
              <a:buNone/>
              <a:defRPr sz="725"/>
            </a:lvl8pPr>
            <a:lvl9pPr marL="2651028" indent="0">
              <a:buNone/>
              <a:defRPr sz="72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755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6526" y="548640"/>
            <a:ext cx="2137642" cy="1920240"/>
          </a:xfrm>
        </p:spPr>
        <p:txBody>
          <a:bodyPr anchor="b"/>
          <a:lstStyle>
            <a:lvl1pPr>
              <a:defRPr sz="231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17684" y="1184912"/>
            <a:ext cx="3355330" cy="5848350"/>
          </a:xfrm>
        </p:spPr>
        <p:txBody>
          <a:bodyPr anchor="t"/>
          <a:lstStyle>
            <a:lvl1pPr marL="0" indent="0">
              <a:buNone/>
              <a:defRPr sz="2319"/>
            </a:lvl1pPr>
            <a:lvl2pPr marL="331379" indent="0">
              <a:buNone/>
              <a:defRPr sz="2029"/>
            </a:lvl2pPr>
            <a:lvl3pPr marL="662757" indent="0">
              <a:buNone/>
              <a:defRPr sz="1740"/>
            </a:lvl3pPr>
            <a:lvl4pPr marL="994136" indent="0">
              <a:buNone/>
              <a:defRPr sz="1450"/>
            </a:lvl4pPr>
            <a:lvl5pPr marL="1325514" indent="0">
              <a:buNone/>
              <a:defRPr sz="1450"/>
            </a:lvl5pPr>
            <a:lvl6pPr marL="1656893" indent="0">
              <a:buNone/>
              <a:defRPr sz="1450"/>
            </a:lvl6pPr>
            <a:lvl7pPr marL="1988271" indent="0">
              <a:buNone/>
              <a:defRPr sz="1450"/>
            </a:lvl7pPr>
            <a:lvl8pPr marL="2319650" indent="0">
              <a:buNone/>
              <a:defRPr sz="1450"/>
            </a:lvl8pPr>
            <a:lvl9pPr marL="2651028" indent="0">
              <a:buNone/>
              <a:defRPr sz="145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6526" y="2468880"/>
            <a:ext cx="2137642" cy="4573906"/>
          </a:xfrm>
        </p:spPr>
        <p:txBody>
          <a:bodyPr/>
          <a:lstStyle>
            <a:lvl1pPr marL="0" indent="0">
              <a:buNone/>
              <a:defRPr sz="1160"/>
            </a:lvl1pPr>
            <a:lvl2pPr marL="331379" indent="0">
              <a:buNone/>
              <a:defRPr sz="1015"/>
            </a:lvl2pPr>
            <a:lvl3pPr marL="662757" indent="0">
              <a:buNone/>
              <a:defRPr sz="870"/>
            </a:lvl3pPr>
            <a:lvl4pPr marL="994136" indent="0">
              <a:buNone/>
              <a:defRPr sz="725"/>
            </a:lvl4pPr>
            <a:lvl5pPr marL="1325514" indent="0">
              <a:buNone/>
              <a:defRPr sz="725"/>
            </a:lvl5pPr>
            <a:lvl6pPr marL="1656893" indent="0">
              <a:buNone/>
              <a:defRPr sz="725"/>
            </a:lvl6pPr>
            <a:lvl7pPr marL="1988271" indent="0">
              <a:buNone/>
              <a:defRPr sz="725"/>
            </a:lvl7pPr>
            <a:lvl8pPr marL="2319650" indent="0">
              <a:buNone/>
              <a:defRPr sz="725"/>
            </a:lvl8pPr>
            <a:lvl9pPr marL="2651028" indent="0">
              <a:buNone/>
              <a:defRPr sz="72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934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5662" y="438152"/>
            <a:ext cx="5716489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662" y="2190750"/>
            <a:ext cx="5716489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5662" y="7627622"/>
            <a:ext cx="1491258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ED039-0B3E-4935-8025-9FA77E41070A}" type="datetimeFigureOut">
              <a:rPr lang="en-US" smtClean="0"/>
              <a:t>6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95463" y="7627622"/>
            <a:ext cx="2236887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80893" y="7627622"/>
            <a:ext cx="1491258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C0E46-4EA7-48F4-AD53-1E8331C08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442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62757" rtl="0" eaLnBrk="1" latinLnBrk="0" hangingPunct="1">
        <a:lnSpc>
          <a:spcPct val="90000"/>
        </a:lnSpc>
        <a:spcBef>
          <a:spcPct val="0"/>
        </a:spcBef>
        <a:buNone/>
        <a:defRPr sz="318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5689" indent="-165689" algn="l" defTabSz="662757" rtl="0" eaLnBrk="1" latinLnBrk="0" hangingPunct="1">
        <a:lnSpc>
          <a:spcPct val="90000"/>
        </a:lnSpc>
        <a:spcBef>
          <a:spcPts val="725"/>
        </a:spcBef>
        <a:buFont typeface="Arial" panose="020B0604020202020204" pitchFamily="34" charset="0"/>
        <a:buChar char="•"/>
        <a:defRPr sz="2029" kern="1200">
          <a:solidFill>
            <a:schemeClr val="tx1"/>
          </a:solidFill>
          <a:latin typeface="+mn-lt"/>
          <a:ea typeface="+mn-ea"/>
          <a:cs typeface="+mn-cs"/>
        </a:defRPr>
      </a:lvl1pPr>
      <a:lvl2pPr marL="497068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740" kern="1200">
          <a:solidFill>
            <a:schemeClr val="tx1"/>
          </a:solidFill>
          <a:latin typeface="+mn-lt"/>
          <a:ea typeface="+mn-ea"/>
          <a:cs typeface="+mn-cs"/>
        </a:defRPr>
      </a:lvl2pPr>
      <a:lvl3pPr marL="828446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450" kern="1200">
          <a:solidFill>
            <a:schemeClr val="tx1"/>
          </a:solidFill>
          <a:latin typeface="+mn-lt"/>
          <a:ea typeface="+mn-ea"/>
          <a:cs typeface="+mn-cs"/>
        </a:defRPr>
      </a:lvl3pPr>
      <a:lvl4pPr marL="1159825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4pPr>
      <a:lvl5pPr marL="1491204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5pPr>
      <a:lvl6pPr marL="1822582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6pPr>
      <a:lvl7pPr marL="2153961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7pPr>
      <a:lvl8pPr marL="2485339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8pPr>
      <a:lvl9pPr marL="2816718" indent="-165689" algn="l" defTabSz="662757" rtl="0" eaLnBrk="1" latinLnBrk="0" hangingPunct="1">
        <a:lnSpc>
          <a:spcPct val="90000"/>
        </a:lnSpc>
        <a:spcBef>
          <a:spcPts val="362"/>
        </a:spcBef>
        <a:buFont typeface="Arial" panose="020B0604020202020204" pitchFamily="34" charset="0"/>
        <a:buChar char="•"/>
        <a:defRPr sz="13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1pPr>
      <a:lvl2pPr marL="331379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2pPr>
      <a:lvl3pPr marL="662757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3pPr>
      <a:lvl4pPr marL="994136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4pPr>
      <a:lvl5pPr marL="1325514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5pPr>
      <a:lvl6pPr marL="1656893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6pPr>
      <a:lvl7pPr marL="1988271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7pPr>
      <a:lvl8pPr marL="2319650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8pPr>
      <a:lvl9pPr marL="2651028" algn="l" defTabSz="662757" rtl="0" eaLnBrk="1" latinLnBrk="0" hangingPunct="1">
        <a:defRPr sz="13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テキスト ボックス 4"/>
          <p:cNvSpPr txBox="1">
            <a:spLocks noChangeArrowheads="1"/>
          </p:cNvSpPr>
          <p:nvPr/>
        </p:nvSpPr>
        <p:spPr bwMode="auto">
          <a:xfrm>
            <a:off x="2783900" y="104815"/>
            <a:ext cx="113204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/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6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Figure </a:t>
            </a:r>
            <a:r>
              <a:rPr lang="en-US" altLang="ja-JP" sz="1600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2</a:t>
            </a:r>
            <a:endParaRPr lang="ja-JP" altLang="en-US" sz="16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36" name="図 3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5942" y="1532629"/>
            <a:ext cx="1254811" cy="905376"/>
          </a:xfrm>
          <a:prstGeom prst="rect">
            <a:avLst/>
          </a:prstGeom>
        </p:spPr>
      </p:pic>
      <p:sp>
        <p:nvSpPr>
          <p:cNvPr id="37" name="テキスト ボックス 36"/>
          <p:cNvSpPr txBox="1"/>
          <p:nvPr/>
        </p:nvSpPr>
        <p:spPr>
          <a:xfrm>
            <a:off x="2144220" y="6512485"/>
            <a:ext cx="9513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D47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36433" y="6047219"/>
            <a:ext cx="21613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</a:t>
            </a:r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1" lang="en-US" altLang="ja-JP" sz="16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erC</a:t>
            </a:r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macrophage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4045251" y="6497140"/>
            <a:ext cx="9513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IRPα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310959" y="839122"/>
            <a:ext cx="12099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</a:t>
            </a:r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MT93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36433" y="839122"/>
            <a:ext cx="1471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</a:t>
            </a:r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 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epa1-6</a:t>
            </a:r>
            <a:endParaRPr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42" name="図 4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725" y="1565420"/>
            <a:ext cx="1202453" cy="905376"/>
          </a:xfrm>
          <a:prstGeom prst="rect">
            <a:avLst/>
          </a:prstGeom>
        </p:spPr>
      </p:pic>
      <p:pic>
        <p:nvPicPr>
          <p:cNvPr id="43" name="図 4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5942" y="2501949"/>
            <a:ext cx="1254811" cy="887226"/>
          </a:xfrm>
          <a:prstGeom prst="rect">
            <a:avLst/>
          </a:prstGeom>
        </p:spPr>
      </p:pic>
      <p:pic>
        <p:nvPicPr>
          <p:cNvPr id="44" name="図 4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5941" y="3453118"/>
            <a:ext cx="1254811" cy="906865"/>
          </a:xfrm>
          <a:prstGeom prst="rect">
            <a:avLst/>
          </a:prstGeom>
        </p:spPr>
      </p:pic>
      <p:pic>
        <p:nvPicPr>
          <p:cNvPr id="45" name="図 4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725" y="2516588"/>
            <a:ext cx="1202453" cy="905377"/>
          </a:xfrm>
          <a:prstGeom prst="rect">
            <a:avLst/>
          </a:prstGeom>
        </p:spPr>
      </p:pic>
      <p:pic>
        <p:nvPicPr>
          <p:cNvPr id="46" name="図 4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725" y="3467757"/>
            <a:ext cx="1204430" cy="906865"/>
          </a:xfrm>
          <a:prstGeom prst="rect">
            <a:avLst/>
          </a:prstGeom>
        </p:spPr>
      </p:pic>
      <p:pic>
        <p:nvPicPr>
          <p:cNvPr id="47" name="図 4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5971" y="1530451"/>
            <a:ext cx="1205345" cy="907554"/>
          </a:xfrm>
          <a:prstGeom prst="rect">
            <a:avLst/>
          </a:prstGeom>
        </p:spPr>
      </p:pic>
      <p:pic>
        <p:nvPicPr>
          <p:cNvPr id="48" name="図 4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5225971" y="2501949"/>
            <a:ext cx="1205345" cy="891222"/>
          </a:xfrm>
          <a:prstGeom prst="rect">
            <a:avLst/>
          </a:prstGeom>
        </p:spPr>
      </p:pic>
      <p:pic>
        <p:nvPicPr>
          <p:cNvPr id="49" name="図 4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5971" y="3434967"/>
            <a:ext cx="1205345" cy="907554"/>
          </a:xfrm>
          <a:prstGeom prst="rect">
            <a:avLst/>
          </a:prstGeom>
        </p:spPr>
      </p:pic>
      <p:pic>
        <p:nvPicPr>
          <p:cNvPr id="50" name="図 4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1288" y="1563242"/>
            <a:ext cx="1205345" cy="907554"/>
          </a:xfrm>
          <a:prstGeom prst="rect">
            <a:avLst/>
          </a:prstGeom>
        </p:spPr>
      </p:pic>
      <p:pic>
        <p:nvPicPr>
          <p:cNvPr id="51" name="図 50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1288" y="2534740"/>
            <a:ext cx="1205345" cy="887225"/>
          </a:xfrm>
          <a:prstGeom prst="rect">
            <a:avLst/>
          </a:prstGeom>
        </p:spPr>
      </p:pic>
      <p:pic>
        <p:nvPicPr>
          <p:cNvPr id="52" name="図 5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1288" y="3485909"/>
            <a:ext cx="1205346" cy="888713"/>
          </a:xfrm>
          <a:prstGeom prst="rect">
            <a:avLst/>
          </a:prstGeom>
        </p:spPr>
      </p:pic>
      <p:sp>
        <p:nvSpPr>
          <p:cNvPr id="53" name="テキスト ボックス 52"/>
          <p:cNvSpPr txBox="1"/>
          <p:nvPr/>
        </p:nvSpPr>
        <p:spPr>
          <a:xfrm>
            <a:off x="3134460" y="1841766"/>
            <a:ext cx="798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naive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134460" y="2778261"/>
            <a:ext cx="798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KD#1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134460" y="3700517"/>
            <a:ext cx="798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KD#2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-49424" y="1841766"/>
            <a:ext cx="798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naive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-49424" y="2778261"/>
            <a:ext cx="798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KD#1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-49424" y="3700517"/>
            <a:ext cx="7982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KD#2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4218884" y="1162103"/>
            <a:ext cx="9513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D47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5352970" y="1150101"/>
            <a:ext cx="9513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IRPα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873467" y="1227097"/>
            <a:ext cx="9513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D47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2007553" y="1215095"/>
            <a:ext cx="9513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IRPα</a:t>
            </a:r>
            <a:endParaRPr kumimoji="1" lang="ja-JP" altLang="en-US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3137635" y="4488488"/>
            <a:ext cx="8078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anti-CD47 </a:t>
            </a:r>
            <a:r>
              <a:rPr kumimoji="1" lang="en-US" altLang="ja-JP" sz="12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Ab</a:t>
            </a:r>
            <a:r>
              <a:rPr kumimoji="1"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1" lang="en-US" altLang="ja-JP" sz="12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loking</a:t>
            </a:r>
            <a:endParaRPr kumimoji="1" lang="ja-JP" altLang="en-US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64" name="図 6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1128" y="6851039"/>
            <a:ext cx="1214437" cy="914400"/>
          </a:xfrm>
          <a:prstGeom prst="rect">
            <a:avLst/>
          </a:prstGeom>
        </p:spPr>
      </p:pic>
      <p:pic>
        <p:nvPicPr>
          <p:cNvPr id="65" name="図 6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7481" y="6852645"/>
            <a:ext cx="1212304" cy="912794"/>
          </a:xfrm>
          <a:prstGeom prst="rect">
            <a:avLst/>
          </a:prstGeom>
        </p:spPr>
      </p:pic>
      <p:pic>
        <p:nvPicPr>
          <p:cNvPr id="66" name="図 6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5941" y="4387224"/>
            <a:ext cx="1254288" cy="944405"/>
          </a:xfrm>
          <a:prstGeom prst="rect">
            <a:avLst/>
          </a:prstGeom>
        </p:spPr>
      </p:pic>
      <p:pic>
        <p:nvPicPr>
          <p:cNvPr id="67" name="図 6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945" y="4425491"/>
            <a:ext cx="1233636" cy="928856"/>
          </a:xfrm>
          <a:prstGeom prst="rect">
            <a:avLst/>
          </a:prstGeom>
        </p:spPr>
      </p:pic>
      <p:sp>
        <p:nvSpPr>
          <p:cNvPr id="68" name="テキスト ボックス 67"/>
          <p:cNvSpPr txBox="1"/>
          <p:nvPr/>
        </p:nvSpPr>
        <p:spPr>
          <a:xfrm>
            <a:off x="-127109" y="4488488"/>
            <a:ext cx="8078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anti-CD47 </a:t>
            </a:r>
            <a:r>
              <a:rPr kumimoji="1" lang="en-US" altLang="ja-JP" sz="12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Ab</a:t>
            </a:r>
            <a:r>
              <a:rPr kumimoji="1" lang="en-US" altLang="ja-JP" sz="12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1" lang="en-US" altLang="ja-JP" sz="12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loking</a:t>
            </a:r>
            <a:endParaRPr kumimoji="1" lang="ja-JP" altLang="en-US" sz="12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12576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033</TotalTime>
  <Words>36</Words>
  <Application>Microsoft Office PowerPoint</Application>
  <PresentationFormat>ユーザー設定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nuki</dc:creator>
  <cp:lastModifiedBy>Sanuki</cp:lastModifiedBy>
  <cp:revision>407</cp:revision>
  <cp:lastPrinted>2017-05-16T06:38:32Z</cp:lastPrinted>
  <dcterms:created xsi:type="dcterms:W3CDTF">2014-04-30T02:57:16Z</dcterms:created>
  <dcterms:modified xsi:type="dcterms:W3CDTF">2018-06-10T09:52:47Z</dcterms:modified>
</cp:coreProperties>
</file>